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6" r:id="rId2"/>
    <p:sldId id="79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5D1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等深淺樣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8" autoAdjust="0"/>
    <p:restoredTop sz="93537" autoAdjust="0"/>
  </p:normalViewPr>
  <p:slideViewPr>
    <p:cSldViewPr snapToGrid="0">
      <p:cViewPr varScale="1">
        <p:scale>
          <a:sx n="106" d="100"/>
          <a:sy n="106" d="100"/>
        </p:scale>
        <p:origin x="18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se, Gary Dr (School of Vet Med.)" userId="cd1b0a45-52ca-42ca-a903-95b4d4bb6a43" providerId="ADAL" clId="{1EE40FB3-D2D0-4A2F-A6B6-CC8F2A6F372E}"/>
    <pc:docChg chg="modSld">
      <pc:chgData name="Tse, Gary Dr (School of Vet Med.)" userId="cd1b0a45-52ca-42ca-a903-95b4d4bb6a43" providerId="ADAL" clId="{1EE40FB3-D2D0-4A2F-A6B6-CC8F2A6F372E}" dt="2020-11-27T06:30:35.233" v="1" actId="20577"/>
      <pc:docMkLst>
        <pc:docMk/>
      </pc:docMkLst>
      <pc:sldChg chg="modSp mod">
        <pc:chgData name="Tse, Gary Dr (School of Vet Med.)" userId="cd1b0a45-52ca-42ca-a903-95b4d4bb6a43" providerId="ADAL" clId="{1EE40FB3-D2D0-4A2F-A6B6-CC8F2A6F372E}" dt="2020-11-27T06:30:35.233" v="1" actId="20577"/>
        <pc:sldMkLst>
          <pc:docMk/>
          <pc:sldMk cId="1411921074" sldId="799"/>
        </pc:sldMkLst>
        <pc:graphicFrameChg chg="modGraphic">
          <ac:chgData name="Tse, Gary Dr (School of Vet Med.)" userId="cd1b0a45-52ca-42ca-a903-95b4d4bb6a43" providerId="ADAL" clId="{1EE40FB3-D2D0-4A2F-A6B6-CC8F2A6F372E}" dt="2020-11-27T06:30:35.233" v="1" actId="20577"/>
          <ac:graphicFrameMkLst>
            <pc:docMk/>
            <pc:sldMk cId="1411921074" sldId="799"/>
            <ac:graphicFrameMk id="2" creationId="{9D3573D5-FFD5-4431-991E-A83F1ECB473A}"/>
          </ac:graphicFrameMkLst>
        </pc:graphicFrameChg>
      </pc:sldChg>
    </pc:docChg>
  </pc:docChgLst>
  <pc:docChgLst>
    <pc:chgData name="Gary Tse" userId="298b4510-61d8-48b7-be9d-a0a45874838a" providerId="ADAL" clId="{DFC2D4CE-463A-4705-83AF-2A46351D8CAB}"/>
    <pc:docChg chg="modSld">
      <pc:chgData name="Gary Tse" userId="298b4510-61d8-48b7-be9d-a0a45874838a" providerId="ADAL" clId="{DFC2D4CE-463A-4705-83AF-2A46351D8CAB}" dt="2020-01-19T03:08:37.492" v="13" actId="20577"/>
      <pc:docMkLst>
        <pc:docMk/>
      </pc:docMkLst>
      <pc:sldChg chg="modSp">
        <pc:chgData name="Gary Tse" userId="298b4510-61d8-48b7-be9d-a0a45874838a" providerId="ADAL" clId="{DFC2D4CE-463A-4705-83AF-2A46351D8CAB}" dt="2020-01-19T03:08:37.492" v="13" actId="20577"/>
        <pc:sldMkLst>
          <pc:docMk/>
          <pc:sldMk cId="1411921074" sldId="799"/>
        </pc:sldMkLst>
        <pc:spChg chg="mod">
          <ac:chgData name="Gary Tse" userId="298b4510-61d8-48b7-be9d-a0a45874838a" providerId="ADAL" clId="{DFC2D4CE-463A-4705-83AF-2A46351D8CAB}" dt="2020-01-19T03:08:37.492" v="13" actId="20577"/>
          <ac:spMkLst>
            <pc:docMk/>
            <pc:sldMk cId="1411921074" sldId="799"/>
            <ac:spMk id="22" creationId="{164A2FA7-1824-480F-A919-865FA06E0D78}"/>
          </ac:spMkLst>
        </pc:spChg>
      </pc:sldChg>
    </pc:docChg>
  </pc:docChgLst>
  <pc:docChgLst>
    <pc:chgData name="Gary Tse" userId="298b4510-61d8-48b7-be9d-a0a45874838a" providerId="ADAL" clId="{AB10C1AC-6F24-4ED8-82B7-D20C145C661A}"/>
    <pc:docChg chg="undo custSel modSld">
      <pc:chgData name="Gary Tse" userId="298b4510-61d8-48b7-be9d-a0a45874838a" providerId="ADAL" clId="{AB10C1AC-6F24-4ED8-82B7-D20C145C661A}" dt="2020-01-20T10:51:32.758" v="738" actId="1076"/>
      <pc:docMkLst>
        <pc:docMk/>
      </pc:docMkLst>
      <pc:sldChg chg="addSp delSp modSp">
        <pc:chgData name="Gary Tse" userId="298b4510-61d8-48b7-be9d-a0a45874838a" providerId="ADAL" clId="{AB10C1AC-6F24-4ED8-82B7-D20C145C661A}" dt="2020-01-20T10:51:32.758" v="738" actId="1076"/>
        <pc:sldMkLst>
          <pc:docMk/>
          <pc:sldMk cId="1411921074" sldId="799"/>
        </pc:sldMkLst>
        <pc:spChg chg="del">
          <ac:chgData name="Gary Tse" userId="298b4510-61d8-48b7-be9d-a0a45874838a" providerId="ADAL" clId="{AB10C1AC-6F24-4ED8-82B7-D20C145C661A}" dt="2020-01-20T10:40:04.577" v="0"/>
          <ac:spMkLst>
            <pc:docMk/>
            <pc:sldMk cId="1411921074" sldId="799"/>
            <ac:spMk id="15" creationId="{683B8380-A8C8-4F37-B24F-44499C771BEB}"/>
          </ac:spMkLst>
        </pc:spChg>
        <pc:spChg chg="mod">
          <ac:chgData name="Gary Tse" userId="298b4510-61d8-48b7-be9d-a0a45874838a" providerId="ADAL" clId="{AB10C1AC-6F24-4ED8-82B7-D20C145C661A}" dt="2020-01-20T10:51:08.462" v="729" actId="1076"/>
          <ac:spMkLst>
            <pc:docMk/>
            <pc:sldMk cId="1411921074" sldId="799"/>
            <ac:spMk id="16" creationId="{32D8F3D5-354E-4EC0-9C3D-916E17CAF8D0}"/>
          </ac:spMkLst>
        </pc:spChg>
        <pc:spChg chg="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17" creationId="{E132C8C7-C2C9-44F7-BCC9-2160004F7233}"/>
          </ac:spMkLst>
        </pc:spChg>
        <pc:spChg chg="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18" creationId="{5A0888F9-5893-4577-B8B1-C4E34F6693A5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20" creationId="{ADF2DF7D-37C8-44D9-A17C-2F41B2E1A003}"/>
          </ac:spMkLst>
        </pc:spChg>
        <pc:spChg chg="del">
          <ac:chgData name="Gary Tse" userId="298b4510-61d8-48b7-be9d-a0a45874838a" providerId="ADAL" clId="{AB10C1AC-6F24-4ED8-82B7-D20C145C661A}" dt="2020-01-20T10:40:04.577" v="0"/>
          <ac:spMkLst>
            <pc:docMk/>
            <pc:sldMk cId="1411921074" sldId="799"/>
            <ac:spMk id="21" creationId="{14B7751A-C1F2-4CEA-BD2E-B4349132E7E8}"/>
          </ac:spMkLst>
        </pc:spChg>
        <pc:spChg chg="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22" creationId="{164A2FA7-1824-480F-A919-865FA06E0D78}"/>
          </ac:spMkLst>
        </pc:spChg>
        <pc:spChg chg="del">
          <ac:chgData name="Gary Tse" userId="298b4510-61d8-48b7-be9d-a0a45874838a" providerId="ADAL" clId="{AB10C1AC-6F24-4ED8-82B7-D20C145C661A}" dt="2020-01-20T10:40:04.577" v="0"/>
          <ac:spMkLst>
            <pc:docMk/>
            <pc:sldMk cId="1411921074" sldId="799"/>
            <ac:spMk id="23" creationId="{D46CB110-FEE4-41D9-866C-8B5B608FD57F}"/>
          </ac:spMkLst>
        </pc:spChg>
        <pc:spChg chg="del">
          <ac:chgData name="Gary Tse" userId="298b4510-61d8-48b7-be9d-a0a45874838a" providerId="ADAL" clId="{AB10C1AC-6F24-4ED8-82B7-D20C145C661A}" dt="2020-01-20T10:40:04.577" v="0"/>
          <ac:spMkLst>
            <pc:docMk/>
            <pc:sldMk cId="1411921074" sldId="799"/>
            <ac:spMk id="24" creationId="{B5E40001-36C2-47A9-912B-D3C251D5E06D}"/>
          </ac:spMkLst>
        </pc:spChg>
        <pc:spChg chg="del">
          <ac:chgData name="Gary Tse" userId="298b4510-61d8-48b7-be9d-a0a45874838a" providerId="ADAL" clId="{AB10C1AC-6F24-4ED8-82B7-D20C145C661A}" dt="2020-01-20T10:40:04.577" v="0"/>
          <ac:spMkLst>
            <pc:docMk/>
            <pc:sldMk cId="1411921074" sldId="799"/>
            <ac:spMk id="25" creationId="{B078DB75-24B1-4488-A1A4-E543C42826B5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27" creationId="{EEBBD2D6-78E4-436B-8F42-027E1767B84D}"/>
          </ac:spMkLst>
        </pc:spChg>
        <pc:spChg chg="mod">
          <ac:chgData name="Gary Tse" userId="298b4510-61d8-48b7-be9d-a0a45874838a" providerId="ADAL" clId="{AB10C1AC-6F24-4ED8-82B7-D20C145C661A}" dt="2020-01-20T10:51:32.758" v="738" actId="1076"/>
          <ac:spMkLst>
            <pc:docMk/>
            <pc:sldMk cId="1411921074" sldId="799"/>
            <ac:spMk id="29" creationId="{4D129979-C06C-4B8C-84C4-6E06FAD0BDE6}"/>
          </ac:spMkLst>
        </pc:spChg>
        <pc:spChg chg="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31" creationId="{424E82B9-399E-46F7-8088-07BE9683A10B}"/>
          </ac:spMkLst>
        </pc:spChg>
        <pc:spChg chg="add del mod">
          <ac:chgData name="Gary Tse" userId="298b4510-61d8-48b7-be9d-a0a45874838a" providerId="ADAL" clId="{AB10C1AC-6F24-4ED8-82B7-D20C145C661A}" dt="2020-01-20T10:44:12.838" v="237"/>
          <ac:spMkLst>
            <pc:docMk/>
            <pc:sldMk cId="1411921074" sldId="799"/>
            <ac:spMk id="32" creationId="{D0C6119C-A7B0-4E74-AEF3-AB522A436B2B}"/>
          </ac:spMkLst>
        </pc:spChg>
        <pc:spChg chg="add del mod">
          <ac:chgData name="Gary Tse" userId="298b4510-61d8-48b7-be9d-a0a45874838a" providerId="ADAL" clId="{AB10C1AC-6F24-4ED8-82B7-D20C145C661A}" dt="2020-01-20T10:45:50.908" v="414"/>
          <ac:spMkLst>
            <pc:docMk/>
            <pc:sldMk cId="1411921074" sldId="799"/>
            <ac:spMk id="33" creationId="{83F33564-6604-4BF1-8978-804F6C235E0F}"/>
          </ac:spMkLst>
        </pc:spChg>
        <pc:spChg chg="add del mod">
          <ac:chgData name="Gary Tse" userId="298b4510-61d8-48b7-be9d-a0a45874838a" providerId="ADAL" clId="{AB10C1AC-6F24-4ED8-82B7-D20C145C661A}" dt="2020-01-20T10:45:51.572" v="415"/>
          <ac:spMkLst>
            <pc:docMk/>
            <pc:sldMk cId="1411921074" sldId="799"/>
            <ac:spMk id="34" creationId="{FFFC085A-F17B-4888-8CE2-0B7311EDFD9B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36" creationId="{E2993AB6-4BDF-425D-A5D6-BA569766A99F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37" creationId="{07524CCC-F42C-4CA3-B2AB-0ADABB8586E8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38" creationId="{E76A8407-826A-435C-A812-BAD380444673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39" creationId="{027C6FC9-8DA5-4962-B687-B1CC36C93E34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40" creationId="{5ED6C67D-49BE-4CEF-8CC9-0BE15D142A76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41" creationId="{32728EB7-A77E-4C0A-9E9B-8A2C7B6E9881}"/>
          </ac:spMkLst>
        </pc:spChg>
        <pc:spChg chg="add mod">
          <ac:chgData name="Gary Tse" userId="298b4510-61d8-48b7-be9d-a0a45874838a" providerId="ADAL" clId="{AB10C1AC-6F24-4ED8-82B7-D20C145C661A}" dt="2020-01-20T10:50:53.734" v="702" actId="1038"/>
          <ac:spMkLst>
            <pc:docMk/>
            <pc:sldMk cId="1411921074" sldId="799"/>
            <ac:spMk id="42" creationId="{31695EA3-0E28-42F3-9E16-0E7B086126A9}"/>
          </ac:spMkLst>
        </pc:spChg>
        <pc:picChg chg="mod">
          <ac:chgData name="Gary Tse" userId="298b4510-61d8-48b7-be9d-a0a45874838a" providerId="ADAL" clId="{AB10C1AC-6F24-4ED8-82B7-D20C145C661A}" dt="2020-01-20T10:51:13.214" v="732" actId="1076"/>
          <ac:picMkLst>
            <pc:docMk/>
            <pc:sldMk cId="1411921074" sldId="799"/>
            <ac:picMk id="12" creationId="{626903CD-62DD-43C6-B3A0-A26C7304EAA1}"/>
          </ac:picMkLst>
        </pc:picChg>
        <pc:picChg chg="mod">
          <ac:chgData name="Gary Tse" userId="298b4510-61d8-48b7-be9d-a0a45874838a" providerId="ADAL" clId="{AB10C1AC-6F24-4ED8-82B7-D20C145C661A}" dt="2020-01-20T10:51:17.518" v="734" actId="1076"/>
          <ac:picMkLst>
            <pc:docMk/>
            <pc:sldMk cId="1411921074" sldId="799"/>
            <ac:picMk id="13" creationId="{56B09843-A689-41FF-92F3-8F64911C26A1}"/>
          </ac:picMkLst>
        </pc:picChg>
        <pc:picChg chg="mod">
          <ac:chgData name="Gary Tse" userId="298b4510-61d8-48b7-be9d-a0a45874838a" providerId="ADAL" clId="{AB10C1AC-6F24-4ED8-82B7-D20C145C661A}" dt="2020-01-20T10:51:24.935" v="736" actId="14100"/>
          <ac:picMkLst>
            <pc:docMk/>
            <pc:sldMk cId="1411921074" sldId="799"/>
            <ac:picMk id="28" creationId="{129E1A5B-3768-438C-AEF0-ED55E1E4D854}"/>
          </ac:picMkLst>
        </pc:picChg>
        <pc:cxnChg chg="mod">
          <ac:chgData name="Gary Tse" userId="298b4510-61d8-48b7-be9d-a0a45874838a" providerId="ADAL" clId="{AB10C1AC-6F24-4ED8-82B7-D20C145C661A}" dt="2020-01-20T10:50:53.734" v="702" actId="1038"/>
          <ac:cxnSpMkLst>
            <pc:docMk/>
            <pc:sldMk cId="1411921074" sldId="799"/>
            <ac:cxnSpMk id="14" creationId="{8DECB61D-5EC3-4A4C-AB52-34ADB1DB3C62}"/>
          </ac:cxnSpMkLst>
        </pc:cxnChg>
        <pc:cxnChg chg="mod">
          <ac:chgData name="Gary Tse" userId="298b4510-61d8-48b7-be9d-a0a45874838a" providerId="ADAL" clId="{AB10C1AC-6F24-4ED8-82B7-D20C145C661A}" dt="2020-01-20T10:50:53.734" v="702" actId="1038"/>
          <ac:cxnSpMkLst>
            <pc:docMk/>
            <pc:sldMk cId="1411921074" sldId="799"/>
            <ac:cxnSpMk id="19" creationId="{B9CD0955-C212-47A9-A5A5-AA54B6D301E3}"/>
          </ac:cxnSpMkLst>
        </pc:cxnChg>
        <pc:cxnChg chg="del">
          <ac:chgData name="Gary Tse" userId="298b4510-61d8-48b7-be9d-a0a45874838a" providerId="ADAL" clId="{AB10C1AC-6F24-4ED8-82B7-D20C145C661A}" dt="2020-01-20T10:40:04.577" v="0"/>
          <ac:cxnSpMkLst>
            <pc:docMk/>
            <pc:sldMk cId="1411921074" sldId="799"/>
            <ac:cxnSpMk id="26" creationId="{BB22FC17-4687-4788-88B4-63A72A245FE9}"/>
          </ac:cxnSpMkLst>
        </pc:cxnChg>
        <pc:cxnChg chg="mod">
          <ac:chgData name="Gary Tse" userId="298b4510-61d8-48b7-be9d-a0a45874838a" providerId="ADAL" clId="{AB10C1AC-6F24-4ED8-82B7-D20C145C661A}" dt="2020-01-20T10:50:53.734" v="702" actId="1038"/>
          <ac:cxnSpMkLst>
            <pc:docMk/>
            <pc:sldMk cId="1411921074" sldId="799"/>
            <ac:cxnSpMk id="30" creationId="{6097CA18-1AF1-4CCC-B6A7-199FAB7C3294}"/>
          </ac:cxnSpMkLst>
        </pc:cxnChg>
        <pc:cxnChg chg="add mod">
          <ac:chgData name="Gary Tse" userId="298b4510-61d8-48b7-be9d-a0a45874838a" providerId="ADAL" clId="{AB10C1AC-6F24-4ED8-82B7-D20C145C661A}" dt="2020-01-20T10:50:53.734" v="702" actId="1038"/>
          <ac:cxnSpMkLst>
            <pc:docMk/>
            <pc:sldMk cId="1411921074" sldId="799"/>
            <ac:cxnSpMk id="35" creationId="{C92E794A-59FC-4351-84D7-0266A6A867FA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9FF06E-DDDE-40E7-AADF-8B1CFCB4AB0D}" type="datetimeFigureOut">
              <a:rPr lang="en-GB" smtClean="0"/>
              <a:t>27/11/2020</a:t>
            </a:fld>
            <a:endParaRPr lang="en-GB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B6DBEC-03F7-4BD6-8BCA-A2C1BB7DD1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643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50E12-70C6-4C3B-8687-76D9B6B9A166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629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5F115-8AEE-43E7-ABF5-34A85ECE202C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4135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473C3-81F6-402D-9A30-3245D7D97760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1356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F3CEB4-8636-4671-914B-4339C4F0E92B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899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669D6-761A-4CA7-A77F-07410D5CF736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36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42C32-06BA-4C6F-A501-0620380FDC7E}" type="datetime1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405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428B14-C1EE-414C-89F8-2C656394081B}" type="datetime1">
              <a:rPr lang="en-GB" smtClean="0"/>
              <a:t>27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123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A893D-352E-4656-AF6F-6DC05212A617}" type="datetime1">
              <a:rPr lang="en-GB" smtClean="0"/>
              <a:t>27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365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D8FBA-EB40-46D4-B4E0-97B9F03A1F16}" type="datetime1">
              <a:rPr lang="en-GB" smtClean="0"/>
              <a:t>27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3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B7EDE-32FA-4DD8-B32E-7BA5E9E15FC7}" type="datetime1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46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35FB20-38E1-472B-8363-201E295DD6EA}" type="datetime1">
              <a:rPr lang="en-GB" smtClean="0"/>
              <a:t>27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619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95ADA-56E1-4FCD-8179-0A7F552E435C}" type="datetime1">
              <a:rPr lang="en-GB" smtClean="0"/>
              <a:t>27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15577-CEA4-4605-AC13-6071FC4F42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3606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screenshot of a cell phone&#10;&#10;Description automatically generated">
            <a:extLst>
              <a:ext uri="{FF2B5EF4-FFF2-40B4-BE49-F238E27FC236}">
                <a16:creationId xmlns:a16="http://schemas.microsoft.com/office/drawing/2014/main" id="{52E9AE50-2DED-4F5E-AA56-735C0827F2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821" y="385799"/>
            <a:ext cx="3708396" cy="2846193"/>
          </a:xfrm>
          <a:prstGeom prst="rect">
            <a:avLst/>
          </a:prstGeom>
        </p:spPr>
      </p:pic>
      <p:pic>
        <p:nvPicPr>
          <p:cNvPr id="11" name="Picture 10" descr="A screenshot of a cell phone&#10;&#10;Description automatically generated">
            <a:extLst>
              <a:ext uri="{FF2B5EF4-FFF2-40B4-BE49-F238E27FC236}">
                <a16:creationId xmlns:a16="http://schemas.microsoft.com/office/drawing/2014/main" id="{FFC9F92E-D20C-49A1-8225-32A4C4FF3D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9016" y="385804"/>
            <a:ext cx="3744984" cy="2846188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F0D53284-DFCC-49E3-BEB4-2ACFD3A3DBC3}"/>
              </a:ext>
            </a:extLst>
          </p:cNvPr>
          <p:cNvCxnSpPr>
            <a:cxnSpLocks/>
          </p:cNvCxnSpPr>
          <p:nvPr/>
        </p:nvCxnSpPr>
        <p:spPr>
          <a:xfrm>
            <a:off x="4046900" y="1649740"/>
            <a:ext cx="118600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5704E8A-E2D4-403A-9BCE-7E5F3FB615E6}"/>
              </a:ext>
            </a:extLst>
          </p:cNvPr>
          <p:cNvSpPr txBox="1"/>
          <p:nvPr/>
        </p:nvSpPr>
        <p:spPr>
          <a:xfrm>
            <a:off x="95821" y="3467356"/>
            <a:ext cx="37083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w data from electrocardiograms (ECGs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2138BA-2BDE-4E4F-A1E5-D349127428C4}"/>
              </a:ext>
            </a:extLst>
          </p:cNvPr>
          <p:cNvSpPr txBox="1"/>
          <p:nvPr/>
        </p:nvSpPr>
        <p:spPr>
          <a:xfrm>
            <a:off x="3804217" y="2031663"/>
            <a:ext cx="16985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traction of automated measurement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55C637-7A52-4F37-BB2C-6591FB72444E}"/>
              </a:ext>
            </a:extLst>
          </p:cNvPr>
          <p:cNvSpPr txBox="1"/>
          <p:nvPr/>
        </p:nvSpPr>
        <p:spPr>
          <a:xfrm>
            <a:off x="5339785" y="3470770"/>
            <a:ext cx="37083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utput of data on P, Q, R, S, T waveform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1664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red, sitting, light, holding&#10;&#10;Description automatically generated">
            <a:extLst>
              <a:ext uri="{FF2B5EF4-FFF2-40B4-BE49-F238E27FC236}">
                <a16:creationId xmlns:a16="http://schemas.microsoft.com/office/drawing/2014/main" id="{626903CD-62DD-43C6-B3A0-A26C7304EA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277" y="891418"/>
            <a:ext cx="1840589" cy="215793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6B09843-A689-41FF-92F3-8F64911C26A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3448590" y="909398"/>
            <a:ext cx="2942428" cy="2139947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8DECB61D-5EC3-4A4C-AB52-34ADB1DB3C62}"/>
              </a:ext>
            </a:extLst>
          </p:cNvPr>
          <p:cNvCxnSpPr/>
          <p:nvPr/>
        </p:nvCxnSpPr>
        <p:spPr>
          <a:xfrm>
            <a:off x="2674966" y="1823901"/>
            <a:ext cx="434566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32D8F3D5-354E-4EC0-9C3D-916E17CAF8D0}"/>
              </a:ext>
            </a:extLst>
          </p:cNvPr>
          <p:cNvSpPr txBox="1"/>
          <p:nvPr/>
        </p:nvSpPr>
        <p:spPr>
          <a:xfrm>
            <a:off x="91005" y="-13931"/>
            <a:ext cx="288933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utomated measurements from ECGs of Brugada syndrome patient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132C8C7-C2C9-44F7-BCC9-2160004F7233}"/>
              </a:ext>
            </a:extLst>
          </p:cNvPr>
          <p:cNvSpPr txBox="1"/>
          <p:nvPr/>
        </p:nvSpPr>
        <p:spPr>
          <a:xfrm>
            <a:off x="3574386" y="47054"/>
            <a:ext cx="52631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ariable selection: Cox regression to identify variables with P &lt; 0.05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B9CD0955-C212-47A9-A5A5-AA54B6D301E3}"/>
              </a:ext>
            </a:extLst>
          </p:cNvPr>
          <p:cNvCxnSpPr/>
          <p:nvPr/>
        </p:nvCxnSpPr>
        <p:spPr>
          <a:xfrm>
            <a:off x="6531743" y="1823901"/>
            <a:ext cx="434566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164A2FA7-1824-480F-A919-865FA06E0D78}"/>
              </a:ext>
            </a:extLst>
          </p:cNvPr>
          <p:cNvSpPr txBox="1"/>
          <p:nvPr/>
        </p:nvSpPr>
        <p:spPr>
          <a:xfrm>
            <a:off x="7079956" y="1000887"/>
            <a:ext cx="1757553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Q, R, S ad T variables from most significant ECG lead identified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 descr="A close up of a map&#10;&#10;Description automatically generated">
            <a:extLst>
              <a:ext uri="{FF2B5EF4-FFF2-40B4-BE49-F238E27FC236}">
                <a16:creationId xmlns:a16="http://schemas.microsoft.com/office/drawing/2014/main" id="{129E1A5B-3768-438C-AEF0-ED55E1E4D8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6774" y="3737847"/>
            <a:ext cx="2115744" cy="153994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4D129979-C06C-4B8C-84C4-6E06FAD0BDE6}"/>
              </a:ext>
            </a:extLst>
          </p:cNvPr>
          <p:cNvSpPr txBox="1"/>
          <p:nvPr/>
        </p:nvSpPr>
        <p:spPr>
          <a:xfrm>
            <a:off x="203837" y="5307669"/>
            <a:ext cx="247104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ptimum cut-off determined from ROC analysi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6097CA18-1AF1-4CCC-B6A7-199FAB7C3294}"/>
              </a:ext>
            </a:extLst>
          </p:cNvPr>
          <p:cNvCxnSpPr/>
          <p:nvPr/>
        </p:nvCxnSpPr>
        <p:spPr>
          <a:xfrm>
            <a:off x="2550632" y="4929242"/>
            <a:ext cx="434566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424E82B9-399E-46F7-8088-07BE9683A10B}"/>
              </a:ext>
            </a:extLst>
          </p:cNvPr>
          <p:cNvSpPr txBox="1"/>
          <p:nvPr/>
        </p:nvSpPr>
        <p:spPr>
          <a:xfrm>
            <a:off x="7256834" y="3456281"/>
            <a:ext cx="1580675" cy="2585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eighted score created based on beta coefficients and P-values of dichotomized variable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C92E794A-59FC-4351-84D7-0266A6A867FA}"/>
              </a:ext>
            </a:extLst>
          </p:cNvPr>
          <p:cNvCxnSpPr/>
          <p:nvPr/>
        </p:nvCxnSpPr>
        <p:spPr>
          <a:xfrm>
            <a:off x="6678844" y="4929242"/>
            <a:ext cx="434566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E2993AB6-4BDF-425D-A5D6-BA569766A99F}"/>
              </a:ext>
            </a:extLst>
          </p:cNvPr>
          <p:cNvSpPr txBox="1"/>
          <p:nvPr/>
        </p:nvSpPr>
        <p:spPr>
          <a:xfrm>
            <a:off x="3206728" y="3263164"/>
            <a:ext cx="33250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inical and ECG variables included: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D3573D5-FFD5-4431-991E-A83F1ECB47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8160761"/>
              </p:ext>
            </p:extLst>
          </p:nvPr>
        </p:nvGraphicFramePr>
        <p:xfrm>
          <a:off x="3206727" y="3573852"/>
          <a:ext cx="3325016" cy="280606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478849">
                  <a:extLst>
                    <a:ext uri="{9D8B030D-6E8A-4147-A177-3AD203B41FA5}">
                      <a16:colId xmlns:a16="http://schemas.microsoft.com/office/drawing/2014/main" val="1945309416"/>
                    </a:ext>
                  </a:extLst>
                </a:gridCol>
                <a:gridCol w="846167">
                  <a:extLst>
                    <a:ext uri="{9D8B030D-6E8A-4147-A177-3AD203B41FA5}">
                      <a16:colId xmlns:a16="http://schemas.microsoft.com/office/drawing/2014/main" val="95246176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Variable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Cut-off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15972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Initial type 1 pattern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5152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Syncope at initial presentation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9717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VT/VF at initial presentation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-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63455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QRS horizontal axis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57.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5405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ST horizontal axis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65.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31281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R-wave amplitude in lead I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0.67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60978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R-wave duration in lead III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</a:rPr>
                        <a:t>50.0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72126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S-wave amplitude in lead I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-0.144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71646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S-wave duration in lead 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effectLst/>
                        </a:rPr>
                        <a:t>aVL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35.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54977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QRS duration in lead V3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96.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4787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QRS area in lead I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0.7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183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ST slope in lead I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31.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9883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T-wave area in V1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-3.05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47891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R interval in V2</a:t>
                      </a:r>
                      <a:endParaRPr lang="en-GB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157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24385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1921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</TotalTime>
  <Words>164</Words>
  <Application>Microsoft Office PowerPoint</Application>
  <PresentationFormat>On-screen Show (4:3)</PresentationFormat>
  <Paragraphs>3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佈景主題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sion of the NDPH research fellowship (5 years)</dc:title>
  <dc:creator>Gary Tse (MEDT)</dc:creator>
  <cp:lastModifiedBy>Tse, Gary Dr (School of Vet Med.)</cp:lastModifiedBy>
  <cp:revision>56</cp:revision>
  <dcterms:created xsi:type="dcterms:W3CDTF">2019-07-31T13:44:12Z</dcterms:created>
  <dcterms:modified xsi:type="dcterms:W3CDTF">2020-11-27T06:30:35Z</dcterms:modified>
</cp:coreProperties>
</file>